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872663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9480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94299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12097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47289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660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3054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2006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61276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24881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81487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5925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D2E46-00DA-438E-8689-7E6315CA8A37}" type="datetimeFigureOut">
              <a:rPr lang="nb-NO" smtClean="0"/>
              <a:t>20.08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5DD31-2334-4CD0-998C-3BFCEBFC513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83019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Bild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7305" y="140558"/>
            <a:ext cx="4234226" cy="6193824"/>
          </a:xfrm>
          <a:prstGeom prst="rect">
            <a:avLst/>
          </a:prstGeom>
        </p:spPr>
      </p:pic>
      <p:pic>
        <p:nvPicPr>
          <p:cNvPr id="18" name="Bild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4487" y="181233"/>
            <a:ext cx="4530094" cy="6642784"/>
          </a:xfrm>
          <a:prstGeom prst="rect">
            <a:avLst/>
          </a:prstGeom>
        </p:spPr>
      </p:pic>
      <p:sp>
        <p:nvSpPr>
          <p:cNvPr id="6" name="TekstSylinder 11"/>
          <p:cNvSpPr txBox="1"/>
          <p:nvPr/>
        </p:nvSpPr>
        <p:spPr>
          <a:xfrm>
            <a:off x="494269" y="387179"/>
            <a:ext cx="409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/>
              <a:t>(A)</a:t>
            </a:r>
            <a:endParaRPr lang="nb-NO" sz="1200" dirty="0"/>
          </a:p>
        </p:txBody>
      </p:sp>
      <p:sp>
        <p:nvSpPr>
          <p:cNvPr id="7" name="TekstSylinder 11"/>
          <p:cNvSpPr txBox="1"/>
          <p:nvPr/>
        </p:nvSpPr>
        <p:spPr>
          <a:xfrm>
            <a:off x="6287656" y="360922"/>
            <a:ext cx="409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/>
              <a:t>(B)</a:t>
            </a:r>
            <a:endParaRPr lang="nb-NO" sz="1200" dirty="0"/>
          </a:p>
        </p:txBody>
      </p:sp>
      <p:cxnSp>
        <p:nvCxnSpPr>
          <p:cNvPr id="9" name="Rett linje 8"/>
          <p:cNvCxnSpPr/>
          <p:nvPr/>
        </p:nvCxnSpPr>
        <p:spPr>
          <a:xfrm>
            <a:off x="5255741" y="156519"/>
            <a:ext cx="0" cy="30727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kstSylinder 11"/>
          <p:cNvSpPr txBox="1"/>
          <p:nvPr/>
        </p:nvSpPr>
        <p:spPr>
          <a:xfrm>
            <a:off x="5261661" y="1415876"/>
            <a:ext cx="1155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notha</a:t>
            </a:r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kstSylinder 11"/>
          <p:cNvSpPr txBox="1"/>
          <p:nvPr/>
        </p:nvSpPr>
        <p:spPr>
          <a:xfrm>
            <a:off x="5231024" y="4138486"/>
            <a:ext cx="14580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glerodendron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macrolobium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acrolobium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Rett linje 12"/>
          <p:cNvCxnSpPr/>
          <p:nvPr/>
        </p:nvCxnSpPr>
        <p:spPr>
          <a:xfrm>
            <a:off x="5198075" y="3270422"/>
            <a:ext cx="0" cy="23642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kstSylinder 11"/>
          <p:cNvSpPr txBox="1"/>
          <p:nvPr/>
        </p:nvSpPr>
        <p:spPr>
          <a:xfrm>
            <a:off x="10719219" y="1395279"/>
            <a:ext cx="1155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notha</a:t>
            </a:r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kstSylinder 11"/>
          <p:cNvSpPr txBox="1"/>
          <p:nvPr/>
        </p:nvSpPr>
        <p:spPr>
          <a:xfrm>
            <a:off x="10680344" y="3738942"/>
            <a:ext cx="14580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glerodendron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macrolobium</a:t>
            </a:r>
            <a:endParaRPr lang="nb-NO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acrolobium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Rett linje 21"/>
          <p:cNvCxnSpPr/>
          <p:nvPr/>
        </p:nvCxnSpPr>
        <p:spPr>
          <a:xfrm>
            <a:off x="10776863" y="140558"/>
            <a:ext cx="0" cy="28744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Rett linje 24"/>
          <p:cNvCxnSpPr/>
          <p:nvPr/>
        </p:nvCxnSpPr>
        <p:spPr>
          <a:xfrm>
            <a:off x="10669769" y="3023287"/>
            <a:ext cx="0" cy="22077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69527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sjon</vt:lpstr>
    </vt:vector>
  </TitlesOfParts>
  <Company>Nibi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Dario Isidro Ojeda Alayon</dc:creator>
  <cp:lastModifiedBy>Dario Isidro Ojeda Alayon</cp:lastModifiedBy>
  <cp:revision>4</cp:revision>
  <cp:lastPrinted>2018-08-20T08:56:20Z</cp:lastPrinted>
  <dcterms:created xsi:type="dcterms:W3CDTF">2018-08-20T08:51:23Z</dcterms:created>
  <dcterms:modified xsi:type="dcterms:W3CDTF">2018-08-20T09:00:25Z</dcterms:modified>
</cp:coreProperties>
</file>